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59" r:id="rId2"/>
    <p:sldId id="258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38" autoAdjust="0"/>
    <p:restoredTop sz="94660"/>
  </p:normalViewPr>
  <p:slideViewPr>
    <p:cSldViewPr snapToGrid="0">
      <p:cViewPr varScale="1">
        <p:scale>
          <a:sx n="119" d="100"/>
          <a:sy n="119" d="100"/>
        </p:scale>
        <p:origin x="102" y="3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CD6D78B-EEF0-44E1-AADA-7F6F7E002AF7}" type="datetimeFigureOut">
              <a:rPr lang="en-US" smtClean="0"/>
              <a:t>2/8/20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4DB7CBE-FF54-415C-8D26-93E857CE9F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87481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11FADAF-5CF0-4F61-A562-2EB1B77FEDE3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972398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F1E06C-7E77-4947-B7C1-2994F607E34D}" type="datetimeFigureOut">
              <a:rPr lang="en-US" smtClean="0"/>
              <a:t>2/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DCEE58-3402-4252-B61A-C61FA2B892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13008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F1E06C-7E77-4947-B7C1-2994F607E34D}" type="datetimeFigureOut">
              <a:rPr lang="en-US" smtClean="0"/>
              <a:t>2/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DCEE58-3402-4252-B61A-C61FA2B892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07073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F1E06C-7E77-4947-B7C1-2994F607E34D}" type="datetimeFigureOut">
              <a:rPr lang="en-US" smtClean="0"/>
              <a:t>2/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DCEE58-3402-4252-B61A-C61FA2B892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01910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F1E06C-7E77-4947-B7C1-2994F607E34D}" type="datetimeFigureOut">
              <a:rPr lang="en-US" smtClean="0"/>
              <a:t>2/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DCEE58-3402-4252-B61A-C61FA2B892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1712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F1E06C-7E77-4947-B7C1-2994F607E34D}" type="datetimeFigureOut">
              <a:rPr lang="en-US" smtClean="0"/>
              <a:t>2/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DCEE58-3402-4252-B61A-C61FA2B892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08228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F1E06C-7E77-4947-B7C1-2994F607E34D}" type="datetimeFigureOut">
              <a:rPr lang="en-US" smtClean="0"/>
              <a:t>2/8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DCEE58-3402-4252-B61A-C61FA2B892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23784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F1E06C-7E77-4947-B7C1-2994F607E34D}" type="datetimeFigureOut">
              <a:rPr lang="en-US" smtClean="0"/>
              <a:t>2/8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DCEE58-3402-4252-B61A-C61FA2B892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46242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F1E06C-7E77-4947-B7C1-2994F607E34D}" type="datetimeFigureOut">
              <a:rPr lang="en-US" smtClean="0"/>
              <a:t>2/8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DCEE58-3402-4252-B61A-C61FA2B892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991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F1E06C-7E77-4947-B7C1-2994F607E34D}" type="datetimeFigureOut">
              <a:rPr lang="en-US" smtClean="0"/>
              <a:t>2/8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DCEE58-3402-4252-B61A-C61FA2B892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34109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F1E06C-7E77-4947-B7C1-2994F607E34D}" type="datetimeFigureOut">
              <a:rPr lang="en-US" smtClean="0"/>
              <a:t>2/8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DCEE58-3402-4252-B61A-C61FA2B892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54273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F1E06C-7E77-4947-B7C1-2994F607E34D}" type="datetimeFigureOut">
              <a:rPr lang="en-US" smtClean="0"/>
              <a:t>2/8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DCEE58-3402-4252-B61A-C61FA2B892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94230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F1E06C-7E77-4947-B7C1-2994F607E34D}" type="datetimeFigureOut">
              <a:rPr lang="en-US" smtClean="0"/>
              <a:t>2/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DCEE58-3402-4252-B61A-C61FA2B892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73520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2927377" y="789455"/>
            <a:ext cx="7866000" cy="14773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 smtClean="0">
                <a:solidFill>
                  <a:srgbClr val="7030A0"/>
                </a:solidFill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GGACACTGACATGGACTGAAGGAGTA</a:t>
            </a:r>
            <a:r>
              <a:rPr lang="en-US" dirty="0">
                <a:solidFill>
                  <a:srgbClr val="1F4E79"/>
                </a:solidFill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GAAA</a:t>
            </a:r>
            <a:r>
              <a:rPr lang="en-US" b="1" u="sng" dirty="0">
                <a:solidFill>
                  <a:srgbClr val="1F4E79"/>
                </a:solidFill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TCCGTAGCCATTTTGGCTCAAG</a:t>
            </a:r>
            <a:r>
              <a:rPr lang="en-US" dirty="0">
                <a:solidFill>
                  <a:srgbClr val="1F4E79"/>
                </a:solidFill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CAGCCAA</a:t>
            </a:r>
            <a:r>
              <a:rPr lang="en-US" u="sng" dirty="0">
                <a:solidFill>
                  <a:srgbClr val="FF0000"/>
                </a:solidFill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AGCTGGCCCAAGCTCTAGGAAACTTTCGCGGCAGCACCTTCTGAGTCAAATCGACCATGGCAAAGCGCAGTGCCAATCTGCTGGTGGCGGCTGTGGTGGCTTGCGCCGTATACGTCCTGCTGCCGGTCGAGAGCTTCGTTGCACCGCAGTCGCTCCGCGGCTCCACCCCACAGGCCGAGGCTGGAGCATTCG</a:t>
            </a:r>
            <a:r>
              <a:rPr lang="en-US" dirty="0" smtClean="0">
                <a:solidFill>
                  <a:srgbClr val="548235"/>
                </a:solidFill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CCCAGGCACCCACCTTTCAG</a:t>
            </a:r>
            <a:endParaRPr lang="en-US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5440465" y="2397337"/>
            <a:ext cx="3459753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solidFill>
                  <a:srgbClr val="7030A0"/>
                </a:solidFill>
              </a:rPr>
              <a:t>5’ RACE forward primer</a:t>
            </a:r>
          </a:p>
          <a:p>
            <a:r>
              <a:rPr lang="en-US" dirty="0" smtClean="0">
                <a:solidFill>
                  <a:schemeClr val="accent5">
                    <a:lumMod val="75000"/>
                  </a:schemeClr>
                </a:solidFill>
              </a:rPr>
              <a:t>5’ UTR</a:t>
            </a:r>
          </a:p>
          <a:p>
            <a:r>
              <a:rPr lang="en-US" b="1" u="sng" dirty="0" smtClean="0">
                <a:solidFill>
                  <a:schemeClr val="accent5">
                    <a:lumMod val="75000"/>
                  </a:schemeClr>
                </a:solidFill>
              </a:rPr>
              <a:t>Splice leader</a:t>
            </a:r>
          </a:p>
          <a:p>
            <a:r>
              <a:rPr lang="en-US" u="sng" dirty="0" smtClean="0">
                <a:solidFill>
                  <a:srgbClr val="FF0000"/>
                </a:solidFill>
              </a:rPr>
              <a:t>Genomic ‘5 Region</a:t>
            </a:r>
          </a:p>
          <a:p>
            <a:r>
              <a:rPr lang="en-US" dirty="0" err="1" smtClean="0">
                <a:solidFill>
                  <a:schemeClr val="accent6">
                    <a:lumMod val="75000"/>
                  </a:schemeClr>
                </a:solidFill>
              </a:rPr>
              <a:t>pPsbJ</a:t>
            </a:r>
            <a:r>
              <a:rPr lang="en-US" dirty="0" smtClean="0">
                <a:solidFill>
                  <a:schemeClr val="accent6">
                    <a:lumMod val="75000"/>
                  </a:schemeClr>
                </a:solidFill>
              </a:rPr>
              <a:t> reverse primer</a:t>
            </a:r>
            <a:endParaRPr lang="en-US" dirty="0">
              <a:solidFill>
                <a:schemeClr val="accent6">
                  <a:lumMod val="75000"/>
                </a:schemeClr>
              </a:solidFill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2472997" y="658901"/>
            <a:ext cx="45438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200" dirty="0"/>
              <a:t>A</a:t>
            </a:r>
          </a:p>
        </p:txBody>
      </p:sp>
    </p:spTree>
    <p:extLst>
      <p:ext uri="{BB962C8B-B14F-4D97-AF65-F5344CB8AC3E}">
        <p14:creationId xmlns:p14="http://schemas.microsoft.com/office/powerpoint/2010/main" val="165931329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4695020" y="5199341"/>
            <a:ext cx="3368841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solidFill>
                  <a:srgbClr val="7030A0"/>
                </a:solidFill>
              </a:rPr>
              <a:t>Common 5’ upstream region</a:t>
            </a:r>
          </a:p>
          <a:p>
            <a:r>
              <a:rPr lang="en-US" u="sng" dirty="0" smtClean="0">
                <a:solidFill>
                  <a:srgbClr val="7030A0"/>
                </a:solidFill>
              </a:rPr>
              <a:t>5’ UTR identi</a:t>
            </a:r>
            <a:r>
              <a:rPr lang="en-US" b="1" u="sng" dirty="0" smtClean="0">
                <a:solidFill>
                  <a:srgbClr val="7030A0"/>
                </a:solidFill>
              </a:rPr>
              <a:t>fied by 5’RACE</a:t>
            </a:r>
          </a:p>
          <a:p>
            <a:r>
              <a:rPr lang="en-US" b="1" u="sng" dirty="0" smtClean="0">
                <a:solidFill>
                  <a:srgbClr val="FF0000"/>
                </a:solidFill>
              </a:rPr>
              <a:t>Putative </a:t>
            </a:r>
            <a:r>
              <a:rPr lang="en-US" b="1" u="sng" dirty="0" err="1" smtClean="0">
                <a:solidFill>
                  <a:srgbClr val="FF0000"/>
                </a:solidFill>
              </a:rPr>
              <a:t>PsbJ</a:t>
            </a:r>
            <a:r>
              <a:rPr lang="en-US" b="1" u="sng" dirty="0" smtClean="0">
                <a:solidFill>
                  <a:srgbClr val="FF0000"/>
                </a:solidFill>
              </a:rPr>
              <a:t> coding sequence</a:t>
            </a:r>
          </a:p>
          <a:p>
            <a:r>
              <a:rPr lang="en-US" dirty="0" smtClean="0">
                <a:solidFill>
                  <a:schemeClr val="accent6"/>
                </a:solidFill>
              </a:rPr>
              <a:t>Common 3’ downstream region</a:t>
            </a:r>
          </a:p>
          <a:p>
            <a:r>
              <a:rPr lang="en-US" dirty="0" smtClean="0">
                <a:solidFill>
                  <a:schemeClr val="accent5">
                    <a:lumMod val="75000"/>
                  </a:schemeClr>
                </a:solidFill>
              </a:rPr>
              <a:t>Spacer sequence </a:t>
            </a:r>
            <a:endParaRPr lang="en-US" dirty="0">
              <a:solidFill>
                <a:schemeClr val="accent5">
                  <a:lumMod val="75000"/>
                </a:schemeClr>
              </a:solidFill>
            </a:endParaRPr>
          </a:p>
        </p:txBody>
      </p:sp>
      <p:sp>
        <p:nvSpPr>
          <p:cNvPr id="5" name="Rectangle 4"/>
          <p:cNvSpPr/>
          <p:nvPr/>
        </p:nvSpPr>
        <p:spPr>
          <a:xfrm>
            <a:off x="765181" y="221547"/>
            <a:ext cx="11228521" cy="504753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CGATAGTGCGGTAGATTGCAGCAA</a:t>
            </a:r>
            <a:r>
              <a:rPr lang="en-US" sz="1400" b="1" dirty="0" smtClean="0">
                <a:solidFill>
                  <a:srgbClr val="7030A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ATGGCAAAGCGCAGCGCCAATCTGCTGGTGGCGGCTGTGGTGGCTTGCGCCGTATACGTCCTGCTGCCGGTCGAGAGCTTCGTTGCACCGCAGTCGCTCCGCGGCTCCACCCCACAGGCCGAGGCTGGAGCATTCGCCCAGGCACCCACCTTTCAGACGGAGGGCCGGTCGGTGCAAGTGAGC</a:t>
            </a:r>
            <a:r>
              <a:rPr lang="en-US" sz="1400" b="1" u="sng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TGGCGGCGACGGGTGGCGAGCCTACAAGGTTTCCCCTCGTCTTCTTGGGCTTGTTGGCGGGCACGGCCGCGGTTGGCCTCCTGGCCGTCTTCTTCTACGGCTCCTACTCTGGTGCGGGCAGCGGCCTGTGA</a:t>
            </a:r>
            <a:r>
              <a:rPr lang="en-US" sz="1400" dirty="0" smtClean="0">
                <a:solidFill>
                  <a:schemeClr val="accent6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CGGCTCTGCAAGTAGGCCGACCGTTTTTGTGCAAAGGGCCAGAATGATGGCTCCAAAGTACCAAGAGCAGCGGGCGAGCACAAAAGAGTGGAGGCGACA</a:t>
            </a:r>
            <a:r>
              <a:rPr lang="en-US" sz="1400" dirty="0" smtClean="0">
                <a:solidFill>
                  <a:schemeClr val="accent5">
                    <a:lumMod val="75000"/>
                  </a:schemeClr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TGTCAGCAGCCATTTTGATCACATTTGTCAGCGACAGGAAAATGGCAGAGGAGAGAGACAGAGCGCGAGCTAGCCGGAGAGAGTGCGAGTCTGCGCAATAGCGACCGGAGAGGCGTGGTCTGCGGTAGTGAGGTAGCACTTCCAGTTGGATCAATCATGGAAGCTTCTGGGGGCTGGGCGCGAGCAAGTGGAAGGGAGATGCTCGCATAGTGATTAATGGGGACTCAGAAACCCGGCTGACTTCGGTGCACACACACACACATCGTGTGCAAAGGGGTAATGTTGCGCCATAGACTCGGCGGAAGGGGCAGATCCTCCTTGCGCTCGTGTCAACTGAAGCAAAGGGCATGGAAAAGGGAGTCTTGCTGGCAGCGGGACAGTCTAACAAGGACATACAGCAGTCCACGCTGAATTTCATGCAGTGGGATGGTTCGGGTGTCCGTATCAAGGACGCTCTC</a:t>
            </a:r>
            <a:r>
              <a:rPr lang="en-US" sz="1400" u="sng" dirty="0" smtClean="0">
                <a:solidFill>
                  <a:srgbClr val="7030A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GCTGGCCCAAGCTCTAGGAAACTTTCGCGGCAGCACCTTCTGAGTCAAATCGAC</a:t>
            </a:r>
            <a:r>
              <a:rPr lang="en-US" sz="1400" b="1" u="sng" dirty="0" smtClean="0">
                <a:solidFill>
                  <a:srgbClr val="7030A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ATGGCAAAGCGCAGCGCCAATCTGCTGGTGGCGGCTGTGGTGGCTTGCGCCGTATACGTCCTGCTGCCGGTCGAGAGCTTCGTTGCACCGCAGTCGCTCCGCGGCTCCACCCCACAGGCCGAGGCTGGAGCATTCGCCCAGGCACCCACCTTTCAGACGGAGGGCCGGTCGGTGCAAGTGAGC</a:t>
            </a:r>
            <a:r>
              <a:rPr lang="en-US" sz="1400" b="1" u="sng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TGGCGGCGACGGGTGGCGAGCCTACAAGGTTTCCCCTCGTCTTCTTGGGCTTGTTGGCGGGCACGGCCGCGGTTGGCCTCCTGGCCGTCTTCTTCTACGGCTCCTACTCTGGTGCGGGCAGCGGCCTGTGA</a:t>
            </a:r>
            <a:r>
              <a:rPr lang="en-US" sz="1400" dirty="0" smtClean="0">
                <a:solidFill>
                  <a:schemeClr val="accent6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CGGCTCTGCAAGTAGGCCGACCGTTTTTGTGCAAAGGGCCAGAATGATGGCTCCAAAGTACCAAGAGCAGCGGGCGAGCACAAAAGAGTGGAGGCGACA</a:t>
            </a:r>
            <a:r>
              <a:rPr lang="en-US" sz="1400" dirty="0" smtClean="0">
                <a:solidFill>
                  <a:schemeClr val="accent5">
                    <a:lumMod val="75000"/>
                  </a:schemeClr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TGTCAGCAGCCATTTTGATCACATTTGTCAGCGACAGGAAAATGGCAGAGGAGAGAGACAGAGCGCGAGCTAGCCGGAGAGAGTGCGAGTCTGCGCAATAGCGACCGGAGAGGCGTGGTCTGCGGTAGTGAGGTAGCACTTCCAGTTGGATCAATCATGGAAGCTTCTGGGGGCTGGGCGCGAGCAAGTGGAAGGGAGATGCTCGCATAGTGATTAATGGGGACTCAGAAACCCGGCTGACTTCGGTGCACACACACACACATCGTGTGCAAAGGGGTAATGTTGCGCCATAGACTCGGCGGAAGGGGCAGATCCTCCTTGCGCTCGTGTCAACTGAAGCAAAGGGCATGGAAAAGGGAGTCTTGCTGGCAGCGGGACAGTCTAACAAGGACATACAGCAGTCCACGCTGAATTTCATGCAGTGGGATGGTTCGGGTGTCCGTATCAAGGACGCTCTC</a:t>
            </a:r>
            <a:r>
              <a:rPr lang="en-US" sz="1400" u="sng" dirty="0" smtClean="0">
                <a:solidFill>
                  <a:srgbClr val="7030A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GCTGGCCCAAGCTCTAGGAAACTTTCGCGGCAGCACCTTCTGAGTCAAATCGAC</a:t>
            </a:r>
            <a:r>
              <a:rPr lang="en-US" sz="1400" b="1" u="sng" dirty="0" smtClean="0">
                <a:solidFill>
                  <a:srgbClr val="7030A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ATGGCAAAGCGCAGCGCCAATCTGCTGGTGGCGGCTGTGGTGGCTTGCGCCGTATACGTCCTGCTGCCGGTCGAGAGCTTCGTTGCACCGCAGTCGCTCCGCGGCTCCACCCCACAGGCCGAGGCTGGAGCATTCGCCCAGGCACCCACCTTTCAGACGGAGGGCCGGTCGGTGCAAGTGAGC</a:t>
            </a:r>
            <a:r>
              <a:rPr lang="en-US" sz="1400" b="1" u="sng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TGGCGGCGACGGGTGGCGAGCCTACAAGGTTTCCCCTCGTCTTCTTGGGCTTGTTGGCGGGCACGGCCGCGGTTGGCCTCCTGGCCGTCTTCTTCTACGGCTCCTACTCTGGTGCGGGCAGCGGCCTGTGA</a:t>
            </a:r>
            <a:r>
              <a:rPr lang="en-US" sz="1400" dirty="0">
                <a:solidFill>
                  <a:schemeClr val="accent6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CGGCTCTGCAAGTAGGCCGACCGTTTTTGTGCAAAGGGCCAGAATGATGGCTCCAAAGTACCAAGAGCAGCGGGCGAGCACAAAAGAGTGGAGGCGACA</a:t>
            </a:r>
            <a:r>
              <a:rPr lang="en-US" sz="14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CAAGCTTGCTCCAAAAGGGCATGC</a:t>
            </a:r>
            <a:endParaRPr lang="en-US" sz="14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310801" y="94518"/>
            <a:ext cx="45438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200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24689463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44</Words>
  <Application>Microsoft Office PowerPoint</Application>
  <PresentationFormat>Widescreen</PresentationFormat>
  <Paragraphs>15</Paragraphs>
  <Slides>2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Courier New</vt:lpstr>
      <vt:lpstr>Office Theme</vt:lpstr>
      <vt:lpstr>PowerPoint Presentation</vt:lpstr>
      <vt:lpstr>PowerPoint Presentation</vt:lpstr>
    </vt:vector>
  </TitlesOfParts>
  <Company>KAUST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it Ern Chen</dc:creator>
  <cp:lastModifiedBy>Jit Ern Chen</cp:lastModifiedBy>
  <cp:revision>4</cp:revision>
  <dcterms:created xsi:type="dcterms:W3CDTF">2017-05-14T09:27:19Z</dcterms:created>
  <dcterms:modified xsi:type="dcterms:W3CDTF">2018-02-08T08:18:45Z</dcterms:modified>
</cp:coreProperties>
</file>